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97" autoAdjust="0"/>
    <p:restoredTop sz="94660"/>
  </p:normalViewPr>
  <p:slideViewPr>
    <p:cSldViewPr snapToGrid="0">
      <p:cViewPr varScale="1">
        <p:scale>
          <a:sx n="60" d="100"/>
          <a:sy n="60" d="100"/>
        </p:scale>
        <p:origin x="3360" y="2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6008C-AD27-401D-A71F-44EEB781BC6D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0D251-19B1-4D2E-A35D-C61191AD3F7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78246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6008C-AD27-401D-A71F-44EEB781BC6D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0D251-19B1-4D2E-A35D-C61191AD3F7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82095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6008C-AD27-401D-A71F-44EEB781BC6D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0D251-19B1-4D2E-A35D-C61191AD3F7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50693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6008C-AD27-401D-A71F-44EEB781BC6D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0D251-19B1-4D2E-A35D-C61191AD3F7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79792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>
                    <a:tint val="82000"/>
                  </a:schemeClr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82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82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6008C-AD27-401D-A71F-44EEB781BC6D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0D251-19B1-4D2E-A35D-C61191AD3F7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24646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6008C-AD27-401D-A71F-44EEB781BC6D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0D251-19B1-4D2E-A35D-C61191AD3F7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01130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6008C-AD27-401D-A71F-44EEB781BC6D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0D251-19B1-4D2E-A35D-C61191AD3F7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93508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6008C-AD27-401D-A71F-44EEB781BC6D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0D251-19B1-4D2E-A35D-C61191AD3F7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52973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6008C-AD27-401D-A71F-44EEB781BC6D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0D251-19B1-4D2E-A35D-C61191AD3F7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45469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6008C-AD27-401D-A71F-44EEB781BC6D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0D251-19B1-4D2E-A35D-C61191AD3F7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8039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6008C-AD27-401D-A71F-44EEB781BC6D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0D251-19B1-4D2E-A35D-C61191AD3F7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28526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A76008C-AD27-401D-A71F-44EEB781BC6D}" type="datetimeFigureOut">
              <a:rPr lang="en-GB" smtClean="0"/>
              <a:t>09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9D0D251-19B1-4D2E-A35D-C61191AD3F7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03560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4A9092CB-2805-95B1-EDE1-E2914B2AE8B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2124" y="689733"/>
            <a:ext cx="2136410" cy="1386717"/>
          </a:xfrm>
          <a:prstGeom prst="rect">
            <a:avLst/>
          </a:prstGeom>
        </p:spPr>
      </p:pic>
      <p:pic>
        <p:nvPicPr>
          <p:cNvPr id="8" name="Picture 7" descr="A graph of different colored lines&#10;&#10;AI-generated content may be incorrect.">
            <a:extLst>
              <a:ext uri="{FF2B5EF4-FFF2-40B4-BE49-F238E27FC236}">
                <a16:creationId xmlns:a16="http://schemas.microsoft.com/office/drawing/2014/main" id="{B7754939-3380-FF5C-0D1C-A964ABA56B9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50737" y="689733"/>
            <a:ext cx="2161784" cy="1386717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3AE21F08-8AF0-7F2C-8B3F-D161D77B1648}"/>
              </a:ext>
            </a:extLst>
          </p:cNvPr>
          <p:cNvSpPr txBox="1"/>
          <p:nvPr/>
        </p:nvSpPr>
        <p:spPr>
          <a:xfrm>
            <a:off x="446750" y="443511"/>
            <a:ext cx="16611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Patient 1 [RESPONDER]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621211F-84C2-5FCB-058C-1C6279C890BF}"/>
              </a:ext>
            </a:extLst>
          </p:cNvPr>
          <p:cNvSpPr txBox="1"/>
          <p:nvPr/>
        </p:nvSpPr>
        <p:spPr>
          <a:xfrm>
            <a:off x="2750736" y="427691"/>
            <a:ext cx="21364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Patient 2 [NON-RESPONDER]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513AB06-7114-010B-364A-54FAD58EFFBB}"/>
              </a:ext>
            </a:extLst>
          </p:cNvPr>
          <p:cNvSpPr txBox="1"/>
          <p:nvPr/>
        </p:nvSpPr>
        <p:spPr>
          <a:xfrm>
            <a:off x="5054724" y="452102"/>
            <a:ext cx="16611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Patient 4 [RESPONDER]*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2A5DABF-4D95-4B9D-A6E2-4B96F801FFCE}"/>
              </a:ext>
            </a:extLst>
          </p:cNvPr>
          <p:cNvSpPr txBox="1"/>
          <p:nvPr/>
        </p:nvSpPr>
        <p:spPr>
          <a:xfrm>
            <a:off x="415105" y="2092270"/>
            <a:ext cx="21849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Patient 5 [NON-RESPONDER]</a:t>
            </a:r>
          </a:p>
        </p:txBody>
      </p:sp>
      <p:pic>
        <p:nvPicPr>
          <p:cNvPr id="14" name="Picture 13" descr="A graph of different colored lines&#10;&#10;AI-generated content may be incorrect.">
            <a:extLst>
              <a:ext uri="{FF2B5EF4-FFF2-40B4-BE49-F238E27FC236}">
                <a16:creationId xmlns:a16="http://schemas.microsoft.com/office/drawing/2014/main" id="{B12F4ED1-FDC2-89AD-1986-7F024D1613B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6750" y="2373676"/>
            <a:ext cx="2161784" cy="1420066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FEA41ADB-3209-EB85-0A79-4963BE927FA9}"/>
              </a:ext>
            </a:extLst>
          </p:cNvPr>
          <p:cNvSpPr txBox="1"/>
          <p:nvPr/>
        </p:nvSpPr>
        <p:spPr>
          <a:xfrm>
            <a:off x="2777324" y="2092271"/>
            <a:ext cx="19534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Patient 6 [NON-RESPONDER]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9D9C26F-C10D-3B2D-02DB-5F56BB80B18B}"/>
              </a:ext>
            </a:extLst>
          </p:cNvPr>
          <p:cNvSpPr txBox="1"/>
          <p:nvPr/>
        </p:nvSpPr>
        <p:spPr>
          <a:xfrm>
            <a:off x="5035105" y="2092272"/>
            <a:ext cx="20316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Patient 7 [NON-RESPONDER] 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7CBD91B7-0480-900B-958A-45014DD8228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77324" y="2373676"/>
            <a:ext cx="2161784" cy="1490428"/>
          </a:xfrm>
          <a:prstGeom prst="rect">
            <a:avLst/>
          </a:prstGeom>
        </p:spPr>
      </p:pic>
      <p:pic>
        <p:nvPicPr>
          <p:cNvPr id="19" name="Picture 18" descr="A graph of different colored lines&#10;&#10;AI-generated content may be incorrect.">
            <a:extLst>
              <a:ext uri="{FF2B5EF4-FFF2-40B4-BE49-F238E27FC236}">
                <a16:creationId xmlns:a16="http://schemas.microsoft.com/office/drawing/2014/main" id="{A1E13EB4-FDE7-08E7-2CEB-0BB0B3497D4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35105" y="2373675"/>
            <a:ext cx="2031613" cy="1490429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7A7B0669-4C2F-EB08-3EC2-01C2B10B389D}"/>
              </a:ext>
            </a:extLst>
          </p:cNvPr>
          <p:cNvSpPr txBox="1"/>
          <p:nvPr/>
        </p:nvSpPr>
        <p:spPr>
          <a:xfrm>
            <a:off x="472123" y="3864104"/>
            <a:ext cx="20316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Patient 10 [NON-RESPONDER] </a:t>
            </a:r>
          </a:p>
        </p:txBody>
      </p:sp>
      <p:pic>
        <p:nvPicPr>
          <p:cNvPr id="22" name="Picture 21" descr="A graph of different colored lines&#10;&#10;AI-generated content may be incorrect.">
            <a:extLst>
              <a:ext uri="{FF2B5EF4-FFF2-40B4-BE49-F238E27FC236}">
                <a16:creationId xmlns:a16="http://schemas.microsoft.com/office/drawing/2014/main" id="{2A2514E7-57E5-78AD-308C-65C6C04AA92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124" y="4180687"/>
            <a:ext cx="2184957" cy="1602924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FD82EC76-C974-9306-FBC0-5C2AB6F53D8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777324" y="4180687"/>
            <a:ext cx="2184957" cy="1602924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4C642056-4A68-E10C-1130-A0C2DFBDFAC5}"/>
              </a:ext>
            </a:extLst>
          </p:cNvPr>
          <p:cNvSpPr txBox="1"/>
          <p:nvPr/>
        </p:nvSpPr>
        <p:spPr>
          <a:xfrm>
            <a:off x="2777324" y="3864103"/>
            <a:ext cx="18873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Patient 11 [NON-RESPONDER] </a:t>
            </a:r>
          </a:p>
        </p:txBody>
      </p:sp>
      <p:pic>
        <p:nvPicPr>
          <p:cNvPr id="26" name="Picture 25" descr="A graph of data on a grid&#10;&#10;AI-generated content may be incorrect.">
            <a:extLst>
              <a:ext uri="{FF2B5EF4-FFF2-40B4-BE49-F238E27FC236}">
                <a16:creationId xmlns:a16="http://schemas.microsoft.com/office/drawing/2014/main" id="{3E079F51-366C-E173-C960-077A5084FDB9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35105" y="4180687"/>
            <a:ext cx="2031614" cy="1602924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4A5E60B6-3FEE-7646-36AA-A0FE2B22485D}"/>
              </a:ext>
            </a:extLst>
          </p:cNvPr>
          <p:cNvSpPr txBox="1"/>
          <p:nvPr/>
        </p:nvSpPr>
        <p:spPr>
          <a:xfrm>
            <a:off x="5035105" y="3864102"/>
            <a:ext cx="16611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Patient 12 [RESPONDER]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FCF7845-C562-9205-1D08-B5480B7CDBE7}"/>
              </a:ext>
            </a:extLst>
          </p:cNvPr>
          <p:cNvSpPr txBox="1"/>
          <p:nvPr/>
        </p:nvSpPr>
        <p:spPr>
          <a:xfrm>
            <a:off x="472124" y="5853972"/>
            <a:ext cx="16611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Patient 13 [RESPONDER] 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2BA500CF-3290-30C2-F874-71BED797E684}"/>
              </a:ext>
            </a:extLst>
          </p:cNvPr>
          <p:cNvSpPr txBox="1"/>
          <p:nvPr/>
        </p:nvSpPr>
        <p:spPr>
          <a:xfrm>
            <a:off x="2777324" y="5853973"/>
            <a:ext cx="16611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Patient 14 [RESPONDER]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3C71AB8B-A8F2-D08D-9295-FC8E5BCB3F08}"/>
              </a:ext>
            </a:extLst>
          </p:cNvPr>
          <p:cNvSpPr txBox="1"/>
          <p:nvPr/>
        </p:nvSpPr>
        <p:spPr>
          <a:xfrm>
            <a:off x="5082524" y="5853972"/>
            <a:ext cx="19342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Patient 15 [NON-RESPONDER] </a:t>
            </a:r>
          </a:p>
        </p:txBody>
      </p:sp>
      <p:pic>
        <p:nvPicPr>
          <p:cNvPr id="32" name="Picture 31" descr="A graph of different colored lines">
            <a:extLst>
              <a:ext uri="{FF2B5EF4-FFF2-40B4-BE49-F238E27FC236}">
                <a16:creationId xmlns:a16="http://schemas.microsoft.com/office/drawing/2014/main" id="{3B171F33-2743-441A-E3EC-D39571683DD3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125" y="6170556"/>
            <a:ext cx="2184956" cy="1602924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34D21FD6-5696-3CA0-7ACA-9B507E303C86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754151" y="6170556"/>
            <a:ext cx="2184957" cy="1602924"/>
          </a:xfrm>
          <a:prstGeom prst="rect">
            <a:avLst/>
          </a:prstGeom>
        </p:spPr>
      </p:pic>
      <p:pic>
        <p:nvPicPr>
          <p:cNvPr id="35" name="Picture 34" descr="A graph of different colored lines&#10;&#10;AI-generated content may be incorrect.">
            <a:extLst>
              <a:ext uri="{FF2B5EF4-FFF2-40B4-BE49-F238E27FC236}">
                <a16:creationId xmlns:a16="http://schemas.microsoft.com/office/drawing/2014/main" id="{E1509F00-0691-6223-643A-0DB2C0370D49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35104" y="6170554"/>
            <a:ext cx="2031613" cy="1602924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F6E3EF99-4D4D-55EC-FE96-0D1E2140B504}"/>
              </a:ext>
            </a:extLst>
          </p:cNvPr>
          <p:cNvSpPr txBox="1"/>
          <p:nvPr/>
        </p:nvSpPr>
        <p:spPr>
          <a:xfrm>
            <a:off x="446750" y="7773478"/>
            <a:ext cx="23039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Patient 16 [NON-RESPONDER]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B9349243-5221-8092-49A1-09062FA35B78}"/>
              </a:ext>
            </a:extLst>
          </p:cNvPr>
          <p:cNvSpPr txBox="1"/>
          <p:nvPr/>
        </p:nvSpPr>
        <p:spPr>
          <a:xfrm>
            <a:off x="2751950" y="7773478"/>
            <a:ext cx="16611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Patient 17 [RESPONDER]</a:t>
            </a:r>
          </a:p>
        </p:txBody>
      </p:sp>
      <p:pic>
        <p:nvPicPr>
          <p:cNvPr id="39" name="Picture 38" descr="A graph of different colored lines&#10;&#10;AI-generated content may be incorrect.">
            <a:extLst>
              <a:ext uri="{FF2B5EF4-FFF2-40B4-BE49-F238E27FC236}">
                <a16:creationId xmlns:a16="http://schemas.microsoft.com/office/drawing/2014/main" id="{D9206F13-6165-E008-1A21-BFAD8DD0895D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793" y="8077361"/>
            <a:ext cx="2184956" cy="1602924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8B653627-C1BB-A4BE-8ADE-4336CF9D5F0E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777323" y="8069371"/>
            <a:ext cx="2184957" cy="1602924"/>
          </a:xfrm>
          <a:prstGeom prst="rect">
            <a:avLst/>
          </a:prstGeom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id="{86BF71D3-836F-8C13-8BE9-0D21DA99059A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5035103" y="673035"/>
            <a:ext cx="2031614" cy="1490429"/>
          </a:xfrm>
          <a:prstGeom prst="rect">
            <a:avLst/>
          </a:prstGeom>
        </p:spPr>
      </p:pic>
      <p:sp>
        <p:nvSpPr>
          <p:cNvPr id="45" name="TextBox 44">
            <a:extLst>
              <a:ext uri="{FF2B5EF4-FFF2-40B4-BE49-F238E27FC236}">
                <a16:creationId xmlns:a16="http://schemas.microsoft.com/office/drawing/2014/main" id="{F910DFA1-F22C-1B66-200A-085B16E7DA97}"/>
              </a:ext>
            </a:extLst>
          </p:cNvPr>
          <p:cNvSpPr txBox="1"/>
          <p:nvPr/>
        </p:nvSpPr>
        <p:spPr>
          <a:xfrm>
            <a:off x="415105" y="9786636"/>
            <a:ext cx="31916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*Period 2 repeated due to technical error in measuring equipment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4802700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8</TotalTime>
  <Words>82</Words>
  <Application>Microsoft Office PowerPoint</Application>
  <PresentationFormat>Custom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r Neil Fawkes</dc:creator>
  <cp:lastModifiedBy>Adam Smith</cp:lastModifiedBy>
  <cp:revision>1</cp:revision>
  <dcterms:created xsi:type="dcterms:W3CDTF">2025-09-09T11:10:25Z</dcterms:created>
  <dcterms:modified xsi:type="dcterms:W3CDTF">2025-09-09T12:53:19Z</dcterms:modified>
</cp:coreProperties>
</file>